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D08E4E-CC16-4367-8C20-5F215877313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E5AA0C-E23A-412F-8842-2BF091BC48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96D513-04BA-46E3-A1DB-35AAC0C7E86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E7B443-7C9E-40CD-A7AC-A104DDE8218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351864-455D-4852-8B36-6B5DF4F7CB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0B96C4-6346-47ED-82A4-238B01F442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E52B87-B7A4-4720-8C26-6AE1814542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818C65-23D4-483A-8C0B-BE17A440F4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4FD1AB-D649-457D-BB53-53833A615A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F5464A-DCE7-495A-BED9-6331295757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43CF14-9B23-4F7F-A0BB-566C211F75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225C55-A523-49E7-AB0F-7D603A7316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01FF48-1EE9-4977-9C24-FA1C68C5E720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http://www.biomedcentral.com/logon/logon.asp?msg=ce" TargetMode="External"/><Relationship Id="rId2" Type="http://schemas.openxmlformats.org/officeDocument/2006/relationships/hyperlink" Target="http://www.biomedcentral.com/1471-5945/6/10" TargetMode="External"/><Relationship Id="rId3" Type="http://schemas.openxmlformats.org/officeDocument/2006/relationships/hyperlink" Target="http://creativecommons.org/licenses/by/2.0" TargetMode="External"/><Relationship Id="rId4" Type="http://schemas.openxmlformats.org/officeDocument/2006/relationships/slideLayout" Target="../slideLayouts/slideLayout3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hyperlink" Target="http://www.biomedcentral.com/1471-5945/6/10" TargetMode="External"/><Relationship Id="rId5" Type="http://schemas.openxmlformats.org/officeDocument/2006/relationships/hyperlink" Target="http://www.biomedcentral.com/1471-5945/6/10" TargetMode="External"/><Relationship Id="rId6" Type="http://schemas.openxmlformats.org/officeDocument/2006/relationships/hyperlink" Target="http://www.biomedcentral.com/1471-5945/6/10" TargetMode="External"/><Relationship Id="rId7" Type="http://schemas.openxmlformats.org/officeDocument/2006/relationships/hyperlink" Target="http://www.biomedcentral.com/1471-5945/6/10" TargetMode="External"/><Relationship Id="rId8" Type="http://schemas.openxmlformats.org/officeDocument/2006/relationships/hyperlink" Target="http://www.biomedcentral.com/1471-5945/6/10" TargetMode="External"/><Relationship Id="rId9" Type="http://schemas.openxmlformats.org/officeDocument/2006/relationships/hyperlink" Target="http://www.biomedcentral.com/1471-5945/6/10" TargetMode="External"/><Relationship Id="rId10" Type="http://schemas.openxmlformats.org/officeDocument/2006/relationships/hyperlink" Target="http://www.biomedcentral.com/1471-5945/6/10" TargetMode="External"/><Relationship Id="rId11" Type="http://schemas.openxmlformats.org/officeDocument/2006/relationships/hyperlink" Target="http://www.biomedcentral.com/1471-5945/6/10" TargetMode="External"/><Relationship Id="rId12" Type="http://schemas.openxmlformats.org/officeDocument/2006/relationships/hyperlink" Target="http://www.biomedcentral.com/1471-5945/6/10" TargetMode="External"/><Relationship Id="rId13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hyperlink" Target="http://www.biomedcentral.com/1471-5945/6/10" TargetMode="External"/><Relationship Id="rId3" Type="http://schemas.openxmlformats.org/officeDocument/2006/relationships/hyperlink" Target="http://www.biomedcentral.com/1471-5945/6/10" TargetMode="External"/><Relationship Id="rId4" Type="http://schemas.openxmlformats.org/officeDocument/2006/relationships/hyperlink" Target="http://www.biomedcentral.com/1471-5945/6/10" TargetMode="External"/><Relationship Id="rId5" Type="http://schemas.openxmlformats.org/officeDocument/2006/relationships/hyperlink" Target="http://www.biomedcentral.com/1471-5945/6/10" TargetMode="External"/><Relationship Id="rId6" Type="http://schemas.openxmlformats.org/officeDocument/2006/relationships/hyperlink" Target="http://www.biomedcentral.com/1471-5945/6/10" TargetMode="External"/><Relationship Id="rId7" Type="http://schemas.openxmlformats.org/officeDocument/2006/relationships/hyperlink" Target="http://www.biomedcentral.com/1471-5945/6/10" TargetMode="External"/><Relationship Id="rId8" Type="http://schemas.openxmlformats.org/officeDocument/2006/relationships/hyperlink" Target="http://www.biomedcentral.com/1471-5945/6/10" TargetMode="External"/><Relationship Id="rId9" Type="http://schemas.openxmlformats.org/officeDocument/2006/relationships/hyperlink" Target="http://www.biomedcentral.com/1471-5945/6/10" TargetMode="External"/><Relationship Id="rId10" Type="http://schemas.openxmlformats.org/officeDocument/2006/relationships/hyperlink" Target="http://www.biomedcentral.com/1471-5945/6/10" TargetMode="External"/><Relationship Id="rId11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hyperlink" Target="http://www.biomedcentral.com/1471-5945/6/10" TargetMode="External"/><Relationship Id="rId3" Type="http://schemas.openxmlformats.org/officeDocument/2006/relationships/hyperlink" Target="http://www.biomedcentral.com/1471-5945/6/10" TargetMode="External"/><Relationship Id="rId4" Type="http://schemas.openxmlformats.org/officeDocument/2006/relationships/hyperlink" Target="http://www.biomedcentral.com/1471-5945/6/10" TargetMode="External"/><Relationship Id="rId5" Type="http://schemas.openxmlformats.org/officeDocument/2006/relationships/hyperlink" Target="http://www.biomedcentral.com/1471-5945/6/10" TargetMode="External"/><Relationship Id="rId6" Type="http://schemas.openxmlformats.org/officeDocument/2006/relationships/hyperlink" Target="http://www.biomedcentral.com/1471-5945/6/10" TargetMode="External"/><Relationship Id="rId7" Type="http://schemas.openxmlformats.org/officeDocument/2006/relationships/hyperlink" Target="http://www.biomedcentral.com/1471-5945/6/10" TargetMode="External"/><Relationship Id="rId8" Type="http://schemas.openxmlformats.org/officeDocument/2006/relationships/hyperlink" Target="http://www.biomedcentral.com/1471-5945/6/10" TargetMode="External"/><Relationship Id="rId9" Type="http://schemas.openxmlformats.org/officeDocument/2006/relationships/hyperlink" Target="http://www.biomedcentral.com/1471-5945/6/10" TargetMode="External"/><Relationship Id="rId10" Type="http://schemas.openxmlformats.org/officeDocument/2006/relationships/hyperlink" Target="http://www.biomedcentral.com/1471-5945/6/10" TargetMode="External"/><Relationship Id="rId1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hyperlink" Target="http://www.biomedcentral.com/1471-5945/6/10" TargetMode="External"/><Relationship Id="rId3" Type="http://schemas.openxmlformats.org/officeDocument/2006/relationships/hyperlink" Target="http://www.biomedcentral.com/1471-5945/6/10" TargetMode="External"/><Relationship Id="rId4" Type="http://schemas.openxmlformats.org/officeDocument/2006/relationships/hyperlink" Target="http://www.biomedcentral.com/1471-5945/6/10" TargetMode="External"/><Relationship Id="rId5" Type="http://schemas.openxmlformats.org/officeDocument/2006/relationships/hyperlink" Target="http://www.biomedcentral.com/1471-5945/6/10" TargetMode="External"/><Relationship Id="rId6" Type="http://schemas.openxmlformats.org/officeDocument/2006/relationships/hyperlink" Target="http://www.biomedcentral.com/1471-5945/6/10" TargetMode="External"/><Relationship Id="rId7" Type="http://schemas.openxmlformats.org/officeDocument/2006/relationships/hyperlink" Target="http://www.biomedcentral.com/1471-5945/6/10" TargetMode="External"/><Relationship Id="rId8" Type="http://schemas.openxmlformats.org/officeDocument/2006/relationships/hyperlink" Target="http://www.biomedcentral.com/1471-5945/6/10" TargetMode="External"/><Relationship Id="rId9" Type="http://schemas.openxmlformats.org/officeDocument/2006/relationships/hyperlink" Target="http://www.biomedcentral.com/1471-5945/6/10" TargetMode="External"/><Relationship Id="rId10" Type="http://schemas.openxmlformats.org/officeDocument/2006/relationships/hyperlink" Target="http://www.biomedcentral.com/1471-5945/6/10" TargetMode="External"/><Relationship Id="rId1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hyperlink" Target="http://www.biomedcentral.com/1471-5945/6/10" TargetMode="External"/><Relationship Id="rId3" Type="http://schemas.openxmlformats.org/officeDocument/2006/relationships/hyperlink" Target="http://www.biomedcentral.com/1471-5945/6/10" TargetMode="External"/><Relationship Id="rId4" Type="http://schemas.openxmlformats.org/officeDocument/2006/relationships/hyperlink" Target="http://www.biomedcentral.com/1471-5945/6/10" TargetMode="External"/><Relationship Id="rId5" Type="http://schemas.openxmlformats.org/officeDocument/2006/relationships/hyperlink" Target="http://www.biomedcentral.com/1471-5945/6/10" TargetMode="External"/><Relationship Id="rId6" Type="http://schemas.openxmlformats.org/officeDocument/2006/relationships/hyperlink" Target="http://www.biomedcentral.com/1471-5945/6/10" TargetMode="External"/><Relationship Id="rId7" Type="http://schemas.openxmlformats.org/officeDocument/2006/relationships/hyperlink" Target="http://www.biomedcentral.com/1471-5945/6/10" TargetMode="External"/><Relationship Id="rId8" Type="http://schemas.openxmlformats.org/officeDocument/2006/relationships/hyperlink" Target="http://www.biomedcentral.com/1471-5945/6/10" TargetMode="External"/><Relationship Id="rId9" Type="http://schemas.openxmlformats.org/officeDocument/2006/relationships/hyperlink" Target="http://www.biomedcentral.com/1471-5945/6/10" TargetMode="External"/><Relationship Id="rId10" Type="http://schemas.openxmlformats.org/officeDocument/2006/relationships/hyperlink" Target="http://www.biomedcentral.com/1471-5945/6/10" TargetMode="External"/><Relationship Id="rId1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hyperlink" Target="http://www.biomedcentral.com/1471-5945/6/10" TargetMode="External"/><Relationship Id="rId3" Type="http://schemas.openxmlformats.org/officeDocument/2006/relationships/hyperlink" Target="http://www.biomedcentral.com/1471-5945/6/10" TargetMode="External"/><Relationship Id="rId4" Type="http://schemas.openxmlformats.org/officeDocument/2006/relationships/hyperlink" Target="http://www.biomedcentral.com/1471-5945/6/10" TargetMode="External"/><Relationship Id="rId5" Type="http://schemas.openxmlformats.org/officeDocument/2006/relationships/hyperlink" Target="http://www.biomedcentral.com/1471-5945/6/10" TargetMode="External"/><Relationship Id="rId6" Type="http://schemas.openxmlformats.org/officeDocument/2006/relationships/hyperlink" Target="http://www.biomedcentral.com/1471-5945/6/10" TargetMode="External"/><Relationship Id="rId7" Type="http://schemas.openxmlformats.org/officeDocument/2006/relationships/hyperlink" Target="http://www.biomedcentral.com/1471-5945/6/10" TargetMode="External"/><Relationship Id="rId8" Type="http://schemas.openxmlformats.org/officeDocument/2006/relationships/hyperlink" Target="http://www.biomedcentral.com/1471-5945/6/10" TargetMode="External"/><Relationship Id="rId9" Type="http://schemas.openxmlformats.org/officeDocument/2006/relationships/hyperlink" Target="http://www.biomedcentral.com/1471-5945/6/10" TargetMode="External"/><Relationship Id="rId10" Type="http://schemas.openxmlformats.org/officeDocument/2006/relationships/hyperlink" Target="http://www.biomedcentral.com/1471-5945/6/10" TargetMode="External"/><Relationship Id="rId11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hyperlink" Target="http://www.biomedcentral.com/1471-5945/6/10" TargetMode="External"/><Relationship Id="rId3" Type="http://schemas.openxmlformats.org/officeDocument/2006/relationships/hyperlink" Target="http://www.biomedcentral.com/1471-5945/6/10" TargetMode="External"/><Relationship Id="rId4" Type="http://schemas.openxmlformats.org/officeDocument/2006/relationships/hyperlink" Target="http://www.biomedcentral.com/1471-5945/6/10" TargetMode="External"/><Relationship Id="rId5" Type="http://schemas.openxmlformats.org/officeDocument/2006/relationships/hyperlink" Target="http://www.biomedcentral.com/1471-5945/6/10" TargetMode="External"/><Relationship Id="rId6" Type="http://schemas.openxmlformats.org/officeDocument/2006/relationships/hyperlink" Target="http://www.biomedcentral.com/1471-5945/6/10" TargetMode="External"/><Relationship Id="rId7" Type="http://schemas.openxmlformats.org/officeDocument/2006/relationships/hyperlink" Target="http://www.biomedcentral.com/1471-5945/6/10" TargetMode="External"/><Relationship Id="rId8" Type="http://schemas.openxmlformats.org/officeDocument/2006/relationships/hyperlink" Target="http://www.biomedcentral.com/1471-5945/6/10" TargetMode="External"/><Relationship Id="rId9" Type="http://schemas.openxmlformats.org/officeDocument/2006/relationships/hyperlink" Target="http://www.biomedcentral.com/1471-5945/6/10" TargetMode="External"/><Relationship Id="rId10" Type="http://schemas.openxmlformats.org/officeDocument/2006/relationships/hyperlink" Target="http://www.biomedcentral.com/1471-5945/6/10" TargetMode="External"/><Relationship Id="rId11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hyperlink" Target="http://www.biomedcentral.com/1471-5945/6/10" TargetMode="External"/><Relationship Id="rId3" Type="http://schemas.openxmlformats.org/officeDocument/2006/relationships/hyperlink" Target="http://www.biomedcentral.com/1471-5945/6/10" TargetMode="External"/><Relationship Id="rId4" Type="http://schemas.openxmlformats.org/officeDocument/2006/relationships/hyperlink" Target="http://www.biomedcentral.com/1471-5945/6/10" TargetMode="External"/><Relationship Id="rId5" Type="http://schemas.openxmlformats.org/officeDocument/2006/relationships/hyperlink" Target="http://www.biomedcentral.com/1471-5945/6/10" TargetMode="External"/><Relationship Id="rId6" Type="http://schemas.openxmlformats.org/officeDocument/2006/relationships/hyperlink" Target="http://www.biomedcentral.com/1471-5945/6/10" TargetMode="External"/><Relationship Id="rId7" Type="http://schemas.openxmlformats.org/officeDocument/2006/relationships/hyperlink" Target="http://www.biomedcentral.com/1471-5945/6/10" TargetMode="External"/><Relationship Id="rId8" Type="http://schemas.openxmlformats.org/officeDocument/2006/relationships/hyperlink" Target="http://www.biomedcentral.com/1471-5945/6/10" TargetMode="External"/><Relationship Id="rId9" Type="http://schemas.openxmlformats.org/officeDocument/2006/relationships/hyperlink" Target="http://www.biomedcentral.com/1471-5945/6/10" TargetMode="External"/><Relationship Id="rId10" Type="http://schemas.openxmlformats.org/officeDocument/2006/relationships/hyperlink" Target="http://www.biomedcentral.com/1471-5945/6/10" TargetMode="External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Times New Roman"/>
              </a:rPr>
              <a:t>Mohs math – where the error hides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/>
          </p:nvPr>
        </p:nvSpPr>
        <p:spPr>
          <a:xfrm>
            <a:off x="685440" y="1981080"/>
            <a:ext cx="807732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1800"/>
            </a:b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Jeffrey I Ellis</a:t>
            </a:r>
            <a:r>
              <a:rPr b="1" lang="en-US" sz="1800" spc="-1" strike="noStrike" baseline="30000">
                <a:solidFill>
                  <a:srgbClr val="000000"/>
                </a:solidFill>
                <a:latin typeface="Times New Roman"/>
              </a:rPr>
              <a:t>1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 (JEllis@JournalReview.org),  Tatiana Khrom</a:t>
            </a:r>
            <a:r>
              <a:rPr b="1" lang="en-US" sz="1800" spc="-1" strike="noStrike" baseline="30000">
                <a:solidFill>
                  <a:srgbClr val="000000"/>
                </a:solidFill>
                <a:latin typeface="Times New Roman"/>
              </a:rPr>
              <a:t>1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, Anthony Wong</a:t>
            </a:r>
            <a:r>
              <a:rPr b="1" lang="en-US" sz="1800" spc="-1" strike="noStrike" baseline="30000">
                <a:solidFill>
                  <a:srgbClr val="000000"/>
                </a:solidFill>
                <a:latin typeface="Times New Roman"/>
              </a:rPr>
              <a:t>1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, Mario O Gentile</a:t>
            </a:r>
            <a:r>
              <a:rPr b="1" lang="en-US" sz="1800" spc="-1" strike="noStrike" baseline="30000">
                <a:solidFill>
                  <a:srgbClr val="000000"/>
                </a:solidFill>
                <a:latin typeface="Times New Roman"/>
              </a:rPr>
              <a:t>2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 and Daniel M Siegel</a:t>
            </a:r>
            <a:r>
              <a:rPr b="1" lang="en-US" sz="1800" spc="-1" strike="noStrike" baseline="30000">
                <a:solidFill>
                  <a:srgbClr val="000000"/>
                </a:solidFill>
                <a:latin typeface="Times New Roman"/>
              </a:rPr>
              <a:t>1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  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 u="sng">
                <a:solidFill>
                  <a:srgbClr val="000066"/>
                </a:solidFill>
                <a:uFillTx/>
                <a:latin typeface="Times New Roman"/>
                <a:hlinkClick r:id="rId1"/>
              </a:rPr>
              <a:t> </a:t>
            </a:r>
            <a:br>
              <a:rPr sz="1800"/>
            </a:b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1.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Department of Dermatology, SUNY Downstate Medical Center, Brooklyn, New York, 11203, USA</a:t>
            </a:r>
            <a:br>
              <a:rPr sz="1600"/>
            </a:b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2.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Jxnstudio.com, Philadelphia, Pennsylvania, USA</a:t>
            </a:r>
            <a:br>
              <a:rPr sz="1600"/>
            </a:br>
            <a:br>
              <a:rPr sz="1600"/>
            </a:b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BMC Dermatology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2006, 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6: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10     doi:10.1186/1471-5945-6-10</a:t>
            </a:r>
            <a:br>
              <a:rPr sz="1600"/>
            </a:b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The electronic version of this article is the complete one and can be found online at: </a:t>
            </a:r>
            <a:r>
              <a:rPr b="0" lang="en-US" sz="1600" spc="-1" strike="noStrike" u="sng">
                <a:solidFill>
                  <a:srgbClr val="000066"/>
                </a:solidFill>
                <a:uFillTx/>
                <a:latin typeface="Times New Roman"/>
                <a:hlinkClick r:id="rId2"/>
              </a:rPr>
              <a:t>http://www.biomedcentral.com/1471-5945/6/10</a:t>
            </a:r>
            <a:br>
              <a:rPr sz="1600"/>
            </a:br>
            <a:br>
              <a:rPr sz="1800"/>
            </a:b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lnSpc>
                <a:spcPct val="80000"/>
              </a:lnSpc>
              <a:spcBef>
                <a:spcPts val="2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Received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 18 August 2006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Accepted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 6 December 2006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Published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 6 December 2006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lnSpc>
                <a:spcPct val="80000"/>
              </a:lnSpc>
              <a:spcBef>
                <a:spcPts val="2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© 2006 Ellis et al; licensee BioMed Central Ltd.</a:t>
            </a:r>
            <a:br>
              <a:rPr sz="900"/>
            </a:b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lnSpc>
                <a:spcPct val="80000"/>
              </a:lnSpc>
              <a:spcBef>
                <a:spcPts val="2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This is an Open Access article distributed under the terms of the Creative Commons Attribution License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  <a:p>
            <a:pPr marL="343080" indent="0">
              <a:lnSpc>
                <a:spcPct val="80000"/>
              </a:lnSpc>
              <a:spcBef>
                <a:spcPts val="2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(</a:t>
            </a:r>
            <a:r>
              <a:rPr b="0" lang="en-US" sz="900" spc="-1" strike="noStrike" u="sng">
                <a:solidFill>
                  <a:srgbClr val="000066"/>
                </a:solidFill>
                <a:uFillTx/>
                <a:latin typeface="Times New Roman"/>
                <a:hlinkClick r:id="rId3"/>
              </a:rPr>
              <a:t>http://creativecommons.org/licenses/by/2.0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), which permits unrestricted use, distribution, and reproduction in any medium, provided the original work is properly cited. 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0" name="" descr=""/>
          <p:cNvPicPr/>
          <p:nvPr/>
        </p:nvPicPr>
        <p:blipFill>
          <a:blip r:embed="rId1"/>
          <a:stretch/>
        </p:blipFill>
        <p:spPr>
          <a:xfrm>
            <a:off x="685800" y="1600200"/>
            <a:ext cx="7848720" cy="5070600"/>
          </a:xfrm>
          <a:prstGeom prst="rect">
            <a:avLst/>
          </a:prstGeom>
          <a:ln w="0">
            <a:noFill/>
          </a:ln>
        </p:spPr>
      </p:pic>
      <p:sp>
        <p:nvSpPr>
          <p:cNvPr id="81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Optimal Processing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4572000" y="6477120"/>
            <a:ext cx="5867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Ellis JI, Khrom T, Wong A, Gentile MO, Siegel DM. </a:t>
            </a:r>
            <a:r>
              <a:rPr b="0" i="1" lang="en-US" sz="700" spc="-1" strike="noStrike">
                <a:solidFill>
                  <a:srgbClr val="000000"/>
                </a:solidFill>
                <a:latin typeface="Times New Roman"/>
              </a:rPr>
              <a:t>Mohs math – where the error hides.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 BMC Dermatology 2006,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6: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10 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 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" descr=""/>
          <p:cNvPicPr/>
          <p:nvPr/>
        </p:nvPicPr>
        <p:blipFill>
          <a:blip r:embed="rId1"/>
          <a:stretch/>
        </p:blipFill>
        <p:spPr>
          <a:xfrm>
            <a:off x="685800" y="1752480"/>
            <a:ext cx="8153280" cy="4832640"/>
          </a:xfrm>
          <a:prstGeom prst="rect">
            <a:avLst/>
          </a:prstGeom>
          <a:ln w="0">
            <a:noFill/>
          </a:ln>
        </p:spPr>
      </p:pic>
      <p:sp>
        <p:nvSpPr>
          <p:cNvPr id="84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Optimal Processing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4572000" y="6477120"/>
            <a:ext cx="5867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Ellis JI, Khrom T, Wong A, Gentile MO, Siegel DM. </a:t>
            </a:r>
            <a:r>
              <a:rPr b="0" i="1" lang="en-US" sz="700" spc="-1" strike="noStrike">
                <a:solidFill>
                  <a:srgbClr val="000000"/>
                </a:solidFill>
                <a:latin typeface="Times New Roman"/>
              </a:rPr>
              <a:t>Mohs math – where the error hides.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 BMC Dermatology 2006,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6: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10 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 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" descr=""/>
          <p:cNvPicPr/>
          <p:nvPr/>
        </p:nvPicPr>
        <p:blipFill>
          <a:blip r:embed="rId1"/>
          <a:stretch/>
        </p:blipFill>
        <p:spPr>
          <a:xfrm>
            <a:off x="685800" y="1523880"/>
            <a:ext cx="6781680" cy="5058000"/>
          </a:xfrm>
          <a:prstGeom prst="rect">
            <a:avLst/>
          </a:prstGeom>
          <a:ln w="0">
            <a:noFill/>
          </a:ln>
        </p:spPr>
      </p:pic>
      <p:sp>
        <p:nvSpPr>
          <p:cNvPr id="87" name=""/>
          <p:cNvSpPr/>
          <p:nvPr/>
        </p:nvSpPr>
        <p:spPr>
          <a:xfrm flipH="1">
            <a:off x="2666880" y="1371600"/>
            <a:ext cx="3353040" cy="1905120"/>
          </a:xfrm>
          <a:prstGeom prst="line">
            <a:avLst/>
          </a:prstGeom>
          <a:ln w="57240">
            <a:solidFill>
              <a:srgbClr val="ff0000"/>
            </a:solidFill>
            <a:miter/>
            <a:headEnd len="med" type="oval" w="med"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6019920" y="1143000"/>
            <a:ext cx="3124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Positive Section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 flipH="1">
            <a:off x="5333760" y="3200400"/>
            <a:ext cx="2361960" cy="1676520"/>
          </a:xfrm>
          <a:prstGeom prst="line">
            <a:avLst/>
          </a:prstGeom>
          <a:ln w="57240">
            <a:solidFill>
              <a:srgbClr val="ff0000"/>
            </a:solidFill>
            <a:miter/>
            <a:headEnd len="med" type="oval" w="med"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7467480" y="3368520"/>
            <a:ext cx="167652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Complete Epidermis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609480" y="22860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Optimal Processing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533520" y="6064200"/>
            <a:ext cx="8229600" cy="64260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Times New Roman"/>
              </a:rPr>
              <a:t>By looking at the specimen from below, we can simulate what tissue would be in the plane of sectioning when processed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>
            <a:off x="4572000" y="6477120"/>
            <a:ext cx="58672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Ellis JI, Khrom T, Wong A, Gentile MO, Siegel DM. </a:t>
            </a:r>
            <a:r>
              <a:rPr b="0" i="1" lang="en-US" sz="700" spc="-1" strike="noStrike">
                <a:solidFill>
                  <a:srgbClr val="000000"/>
                </a:solidFill>
                <a:latin typeface="Times New Roman"/>
              </a:rPr>
              <a:t>Mohs math – where the error hides.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 BMC Dermatology 2006, </a:t>
            </a:r>
            <a:r>
              <a:rPr b="1" lang="en-US" sz="700" spc="-1" strike="noStrike">
                <a:solidFill>
                  <a:srgbClr val="000000"/>
                </a:solidFill>
                <a:latin typeface="Times New Roman"/>
              </a:rPr>
              <a:t>6: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</a:rPr>
              <a:t>10 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 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The Model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685800" y="1600200"/>
            <a:ext cx="3505320" cy="240660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2"/>
          <a:stretch/>
        </p:blipFill>
        <p:spPr>
          <a:xfrm>
            <a:off x="665280" y="4299120"/>
            <a:ext cx="3906720" cy="247320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3"/>
          <a:stretch/>
        </p:blipFill>
        <p:spPr>
          <a:xfrm>
            <a:off x="4724280" y="2438280"/>
            <a:ext cx="4038840" cy="331020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 flipH="1">
            <a:off x="2666880" y="2057400"/>
            <a:ext cx="1981440" cy="914400"/>
          </a:xfrm>
          <a:prstGeom prst="line">
            <a:avLst/>
          </a:prstGeom>
          <a:ln w="57240">
            <a:solidFill>
              <a:srgbClr val="ff0000"/>
            </a:solidFill>
            <a:miter/>
            <a:headEnd len="med" type="oval" w="med"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 flipH="1">
            <a:off x="3428640" y="1066680"/>
            <a:ext cx="1981080" cy="914400"/>
          </a:xfrm>
          <a:prstGeom prst="line">
            <a:avLst/>
          </a:prstGeom>
          <a:ln w="57240">
            <a:solidFill>
              <a:srgbClr val="ff0000"/>
            </a:solidFill>
            <a:miter/>
            <a:headEnd len="med" type="oval" w="med"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 flipH="1" flipV="1">
            <a:off x="2819520" y="5638680"/>
            <a:ext cx="2209680" cy="609840"/>
          </a:xfrm>
          <a:prstGeom prst="line">
            <a:avLst/>
          </a:prstGeom>
          <a:ln w="57240">
            <a:solidFill>
              <a:srgbClr val="ff0000"/>
            </a:solidFill>
            <a:miter/>
            <a:headEnd len="med" type="oval" w="med"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4648320" y="2057400"/>
            <a:ext cx="1676160" cy="2514600"/>
          </a:xfrm>
          <a:prstGeom prst="line">
            <a:avLst/>
          </a:prstGeom>
          <a:ln w="57240">
            <a:solidFill>
              <a:srgbClr val="ff0000"/>
            </a:solidFill>
            <a:miter/>
            <a:headEnd len="med" type="oval" w="med"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5486400" y="762120"/>
            <a:ext cx="3124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Dermis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4724280" y="1828800"/>
            <a:ext cx="31244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Tumor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5029200" y="6019920"/>
            <a:ext cx="3124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ahoma"/>
              </a:rPr>
              <a:t>Epithelium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4572000" y="6477120"/>
            <a:ext cx="5867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4"/>
              </a:rPr>
              <a:t>Ellis JI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5"/>
              </a:rPr>
              <a:t>Khrom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6"/>
              </a:rPr>
              <a:t> T, Wong A, Gentile MO, Siegel DM.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7"/>
              </a:rPr>
              <a:t>Mohs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8"/>
              </a:rPr>
              <a:t> math – where the error hides.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9"/>
              </a:rPr>
              <a:t> BMC Dermatology 2006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0"/>
              </a:rPr>
              <a:t>6: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1"/>
              </a:rPr>
              <a:t>10 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2"/>
              </a:rPr>
              <a:t> 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Optimal Processing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57" name="" descr=""/>
          <p:cNvPicPr/>
          <p:nvPr/>
        </p:nvPicPr>
        <p:blipFill>
          <a:blip r:embed="rId1"/>
          <a:stretch/>
        </p:blipFill>
        <p:spPr>
          <a:xfrm>
            <a:off x="666720" y="1704960"/>
            <a:ext cx="7943760" cy="4162320"/>
          </a:xfrm>
          <a:prstGeom prst="rect">
            <a:avLst/>
          </a:prstGeom>
          <a:ln w="0">
            <a:noFill/>
          </a:ln>
        </p:spPr>
      </p:pic>
      <p:sp>
        <p:nvSpPr>
          <p:cNvPr id="58" name=""/>
          <p:cNvSpPr/>
          <p:nvPr/>
        </p:nvSpPr>
        <p:spPr>
          <a:xfrm>
            <a:off x="685800" y="6095880"/>
            <a:ext cx="7391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First, an excised layer is cut into blocks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4572000" y="6477120"/>
            <a:ext cx="5867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2"/>
              </a:rPr>
              <a:t>Ellis JI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3"/>
              </a:rPr>
              <a:t>Khrom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4"/>
              </a:rPr>
              <a:t> T, Wong A, Gentile MO, Siegel DM.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5"/>
              </a:rPr>
              <a:t>Mohs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6"/>
              </a:rPr>
              <a:t> math – where the error hides.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7"/>
              </a:rPr>
              <a:t> BMC Dermatology 2006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8"/>
              </a:rPr>
              <a:t>6: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9"/>
              </a:rPr>
              <a:t>10 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0"/>
              </a:rPr>
              <a:t> 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" descr=""/>
          <p:cNvPicPr/>
          <p:nvPr/>
        </p:nvPicPr>
        <p:blipFill>
          <a:blip r:embed="rId1"/>
          <a:stretch/>
        </p:blipFill>
        <p:spPr>
          <a:xfrm>
            <a:off x="685800" y="1447920"/>
            <a:ext cx="6934320" cy="5108400"/>
          </a:xfrm>
          <a:prstGeom prst="rect">
            <a:avLst/>
          </a:prstGeom>
          <a:ln w="0">
            <a:noFill/>
          </a:ln>
        </p:spPr>
      </p:pic>
      <p:sp>
        <p:nvSpPr>
          <p:cNvPr id="61" name=""/>
          <p:cNvSpPr/>
          <p:nvPr/>
        </p:nvSpPr>
        <p:spPr>
          <a:xfrm>
            <a:off x="609480" y="15228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Optimal Processing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533520" y="6338880"/>
            <a:ext cx="8229600" cy="3682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Times New Roman"/>
              </a:rPr>
              <a:t>The block must be flattened to allow for complete analysis of the surgical margin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4572000" y="6477120"/>
            <a:ext cx="5867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2"/>
              </a:rPr>
              <a:t>Ellis JI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3"/>
              </a:rPr>
              <a:t>Khrom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4"/>
              </a:rPr>
              <a:t> T, Wong A, Gentile MO, Siegel DM.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5"/>
              </a:rPr>
              <a:t>Mohs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6"/>
              </a:rPr>
              <a:t> math – where the error hides.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7"/>
              </a:rPr>
              <a:t> BMC Dermatology 2006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8"/>
              </a:rPr>
              <a:t>6: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9"/>
              </a:rPr>
              <a:t>10 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0"/>
              </a:rPr>
              <a:t> 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" descr=""/>
          <p:cNvPicPr/>
          <p:nvPr/>
        </p:nvPicPr>
        <p:blipFill>
          <a:blip r:embed="rId1"/>
          <a:stretch/>
        </p:blipFill>
        <p:spPr>
          <a:xfrm>
            <a:off x="685800" y="1600200"/>
            <a:ext cx="7010280" cy="5099040"/>
          </a:xfrm>
          <a:prstGeom prst="rect">
            <a:avLst/>
          </a:prstGeom>
          <a:ln w="0">
            <a:noFill/>
          </a:ln>
        </p:spPr>
      </p:pic>
      <p:sp>
        <p:nvSpPr>
          <p:cNvPr id="65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Optimal Processing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4572000" y="6477120"/>
            <a:ext cx="5867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2"/>
              </a:rPr>
              <a:t>Ellis JI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3"/>
              </a:rPr>
              <a:t>Khrom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4"/>
              </a:rPr>
              <a:t> T, Wong A, Gentile MO, Siegel DM.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5"/>
              </a:rPr>
              <a:t>Mohs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6"/>
              </a:rPr>
              <a:t> math – where the error hides.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7"/>
              </a:rPr>
              <a:t> BMC Dermatology 2006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8"/>
              </a:rPr>
              <a:t>6: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9"/>
              </a:rPr>
              <a:t>10 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0"/>
              </a:rPr>
              <a:t> 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" descr=""/>
          <p:cNvPicPr/>
          <p:nvPr/>
        </p:nvPicPr>
        <p:blipFill>
          <a:blip r:embed="rId1"/>
          <a:stretch/>
        </p:blipFill>
        <p:spPr>
          <a:xfrm>
            <a:off x="685800" y="1600200"/>
            <a:ext cx="7010280" cy="5100480"/>
          </a:xfrm>
          <a:prstGeom prst="rect">
            <a:avLst/>
          </a:prstGeom>
          <a:ln w="0">
            <a:noFill/>
          </a:ln>
        </p:spPr>
      </p:pic>
      <p:sp>
        <p:nvSpPr>
          <p:cNvPr id="68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Optimal Processing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4572000" y="6477120"/>
            <a:ext cx="5867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2"/>
              </a:rPr>
              <a:t>Ellis JI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3"/>
              </a:rPr>
              <a:t>Khrom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4"/>
              </a:rPr>
              <a:t> T, Wong A, Gentile MO, Siegel DM.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5"/>
              </a:rPr>
              <a:t>Mohs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6"/>
              </a:rPr>
              <a:t> math – where the error hides.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7"/>
              </a:rPr>
              <a:t> BMC Dermatology 2006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8"/>
              </a:rPr>
              <a:t>6: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9"/>
              </a:rPr>
              <a:t>10 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0"/>
              </a:rPr>
              <a:t> 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" descr=""/>
          <p:cNvPicPr/>
          <p:nvPr/>
        </p:nvPicPr>
        <p:blipFill>
          <a:blip r:embed="rId1"/>
          <a:stretch/>
        </p:blipFill>
        <p:spPr>
          <a:xfrm>
            <a:off x="685800" y="1600200"/>
            <a:ext cx="7086600" cy="5156280"/>
          </a:xfrm>
          <a:prstGeom prst="rect">
            <a:avLst/>
          </a:prstGeom>
          <a:ln w="0">
            <a:noFill/>
          </a:ln>
        </p:spPr>
      </p:pic>
      <p:sp>
        <p:nvSpPr>
          <p:cNvPr id="71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Optimal Processing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4572000" y="6477120"/>
            <a:ext cx="5867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2"/>
              </a:rPr>
              <a:t>Ellis JI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3"/>
              </a:rPr>
              <a:t>Khrom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4"/>
              </a:rPr>
              <a:t> T, Wong A, Gentile MO, Siegel DM.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5"/>
              </a:rPr>
              <a:t>Mohs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6"/>
              </a:rPr>
              <a:t> math – where the error hides.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7"/>
              </a:rPr>
              <a:t> BMC Dermatology 2006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8"/>
              </a:rPr>
              <a:t>6: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9"/>
              </a:rPr>
              <a:t>10 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0"/>
              </a:rPr>
              <a:t> 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3" name="" descr=""/>
          <p:cNvPicPr/>
          <p:nvPr/>
        </p:nvPicPr>
        <p:blipFill>
          <a:blip r:embed="rId1"/>
          <a:stretch/>
        </p:blipFill>
        <p:spPr>
          <a:xfrm>
            <a:off x="685800" y="1600200"/>
            <a:ext cx="7010280" cy="5100480"/>
          </a:xfrm>
          <a:prstGeom prst="rect">
            <a:avLst/>
          </a:prstGeom>
          <a:ln w="0">
            <a:noFill/>
          </a:ln>
        </p:spPr>
      </p:pic>
      <p:sp>
        <p:nvSpPr>
          <p:cNvPr id="74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Optimal Processing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4572000" y="6477120"/>
            <a:ext cx="5867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2"/>
              </a:rPr>
              <a:t>Ellis JI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3"/>
              </a:rPr>
              <a:t>Khrom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4"/>
              </a:rPr>
              <a:t> T, Wong A, Gentile MO, Siegel DM.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5"/>
              </a:rPr>
              <a:t>Mohs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6"/>
              </a:rPr>
              <a:t> math – where the error hides.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7"/>
              </a:rPr>
              <a:t> BMC Dermatology 2006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8"/>
              </a:rPr>
              <a:t>6: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9"/>
              </a:rPr>
              <a:t>10 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0"/>
              </a:rPr>
              <a:t> 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" descr=""/>
          <p:cNvPicPr/>
          <p:nvPr/>
        </p:nvPicPr>
        <p:blipFill>
          <a:blip r:embed="rId1"/>
          <a:stretch/>
        </p:blipFill>
        <p:spPr>
          <a:xfrm>
            <a:off x="685800" y="1600200"/>
            <a:ext cx="6915240" cy="5038560"/>
          </a:xfrm>
          <a:prstGeom prst="rect">
            <a:avLst/>
          </a:prstGeom>
          <a:ln w="0">
            <a:noFill/>
          </a:ln>
        </p:spPr>
      </p:pic>
      <p:sp>
        <p:nvSpPr>
          <p:cNvPr id="77" name=""/>
          <p:cNvSpPr/>
          <p:nvPr/>
        </p:nvSpPr>
        <p:spPr>
          <a:xfrm>
            <a:off x="609480" y="304920"/>
            <a:ext cx="77724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Optimal Processing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8610480" y="6553080"/>
            <a:ext cx="152640" cy="152640"/>
          </a:xfrm>
          <a:prstGeom prst="ellipse">
            <a:avLst/>
          </a:prstGeom>
          <a:solidFill>
            <a:srgbClr val="00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4572000" y="6477120"/>
            <a:ext cx="5867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2"/>
              </a:rPr>
              <a:t>Ellis JI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3"/>
              </a:rPr>
              <a:t>Khrom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4"/>
              </a:rPr>
              <a:t> T, Wong A, Gentile MO, Siegel DM.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5"/>
              </a:rPr>
              <a:t>Mohs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6"/>
              </a:rPr>
              <a:t> math – where the error hides.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7"/>
              </a:rPr>
              <a:t> BMC Dermatology 2006, 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8"/>
              </a:rPr>
              <a:t>6: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9"/>
              </a:rPr>
              <a:t>10 </a:t>
            </a:r>
            <a:r>
              <a:rPr b="0" lang="en-US" sz="700" spc="-1" strike="noStrike" u="sng">
                <a:solidFill>
                  <a:srgbClr val="000066"/>
                </a:solidFill>
                <a:uFillTx/>
                <a:latin typeface="Times New Roman"/>
                <a:hlinkClick r:id="rId10"/>
              </a:rPr>
              <a:t> </a:t>
            </a:r>
            <a:endParaRPr b="0" lang="en-US" sz="7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1-09T15:05:13Z</dcterms:created>
  <dc:creator>je</dc:creator>
  <dc:description/>
  <dc:language>en-US</dc:language>
  <cp:lastModifiedBy>JE</cp:lastModifiedBy>
  <dcterms:modified xsi:type="dcterms:W3CDTF">2007-01-03T17:02:57Z</dcterms:modified>
  <cp:revision>7</cp:revision>
  <dc:subject/>
  <dc:title>The Model</dc:title>
</cp:coreProperties>
</file>